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5A317E4-AEB0-49B4-8D63-8BF26CD20559}" v="19" dt="2026-04-10T19:18:28.3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5" autoAdjust="0"/>
    <p:restoredTop sz="95008" autoAdjust="0"/>
  </p:normalViewPr>
  <p:slideViewPr>
    <p:cSldViewPr snapToGrid="0">
      <p:cViewPr>
        <p:scale>
          <a:sx n="87" d="100"/>
          <a:sy n="87" d="100"/>
        </p:scale>
        <p:origin x="-1232" y="-72"/>
      </p:cViewPr>
      <p:guideLst>
        <p:guide orient="horz" pos="28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4" Type="http://schemas.microsoft.com/office/2016/11/relationships/changesInfo" Target="changesInfos/changesInfo1.xml"/><Relationship Id="rId15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wn Holmes" userId="b7a8a953-5552-462e-ab5c-f3e22cb2b5df" providerId="ADAL" clId="{91CB56AA-EA07-4E7B-8CF8-687302C44E3C}"/>
    <pc:docChg chg="custSel addSld modSld">
      <pc:chgData name="Dawn Holmes" userId="b7a8a953-5552-462e-ab5c-f3e22cb2b5df" providerId="ADAL" clId="{91CB56AA-EA07-4E7B-8CF8-687302C44E3C}" dt="2026-04-10T19:20:28.430" v="605" actId="207"/>
      <pc:docMkLst>
        <pc:docMk/>
      </pc:docMkLst>
      <pc:sldChg chg="addSp modSp mod">
        <pc:chgData name="Dawn Holmes" userId="b7a8a953-5552-462e-ab5c-f3e22cb2b5df" providerId="ADAL" clId="{91CB56AA-EA07-4E7B-8CF8-687302C44E3C}" dt="2026-04-10T00:15:26.567" v="155" actId="207"/>
        <pc:sldMkLst>
          <pc:docMk/>
          <pc:sldMk cId="671102180" sldId="256"/>
        </pc:sldMkLst>
        <pc:spChg chg="mod">
          <ac:chgData name="Dawn Holmes" userId="b7a8a953-5552-462e-ab5c-f3e22cb2b5df" providerId="ADAL" clId="{91CB56AA-EA07-4E7B-8CF8-687302C44E3C}" dt="2026-04-10T00:03:59.638" v="1" actId="1076"/>
          <ac:spMkLst>
            <pc:docMk/>
            <pc:sldMk cId="671102180" sldId="256"/>
            <ac:spMk id="11" creationId="{AA663383-1628-7291-2815-9D12F1DC382B}"/>
          </ac:spMkLst>
        </pc:spChg>
        <pc:spChg chg="mod">
          <ac:chgData name="Dawn Holmes" userId="b7a8a953-5552-462e-ab5c-f3e22cb2b5df" providerId="ADAL" clId="{91CB56AA-EA07-4E7B-8CF8-687302C44E3C}" dt="2026-04-10T00:03:55.246" v="0" actId="1076"/>
          <ac:spMkLst>
            <pc:docMk/>
            <pc:sldMk cId="671102180" sldId="256"/>
            <ac:spMk id="12" creationId="{679631EA-9229-3F19-A6B1-3D3A89B9F62E}"/>
          </ac:spMkLst>
        </pc:spChg>
        <pc:spChg chg="add mod">
          <ac:chgData name="Dawn Holmes" userId="b7a8a953-5552-462e-ab5c-f3e22cb2b5df" providerId="ADAL" clId="{91CB56AA-EA07-4E7B-8CF8-687302C44E3C}" dt="2026-04-10T00:07:09.998" v="66" actId="1076"/>
          <ac:spMkLst>
            <pc:docMk/>
            <pc:sldMk cId="671102180" sldId="256"/>
            <ac:spMk id="15" creationId="{F866B512-F850-8A8C-073D-65EC2B8C9C48}"/>
          </ac:spMkLst>
        </pc:spChg>
        <pc:graphicFrameChg chg="add mod modGraphic">
          <ac:chgData name="Dawn Holmes" userId="b7a8a953-5552-462e-ab5c-f3e22cb2b5df" providerId="ADAL" clId="{91CB56AA-EA07-4E7B-8CF8-687302C44E3C}" dt="2026-04-10T00:15:26.567" v="155" actId="207"/>
          <ac:graphicFrameMkLst>
            <pc:docMk/>
            <pc:sldMk cId="671102180" sldId="256"/>
            <ac:graphicFrameMk id="13" creationId="{952E3C18-079C-AB36-668D-C04B8D602FEF}"/>
          </ac:graphicFrameMkLst>
        </pc:graphicFrameChg>
        <pc:picChg chg="mod">
          <ac:chgData name="Dawn Holmes" userId="b7a8a953-5552-462e-ab5c-f3e22cb2b5df" providerId="ADAL" clId="{91CB56AA-EA07-4E7B-8CF8-687302C44E3C}" dt="2026-04-10T00:03:55.246" v="0" actId="1076"/>
          <ac:picMkLst>
            <pc:docMk/>
            <pc:sldMk cId="671102180" sldId="256"/>
            <ac:picMk id="7" creationId="{BFD5C40A-E2CF-EC8A-4EA0-0DC77CBDAA02}"/>
          </ac:picMkLst>
        </pc:picChg>
        <pc:picChg chg="mod">
          <ac:chgData name="Dawn Holmes" userId="b7a8a953-5552-462e-ab5c-f3e22cb2b5df" providerId="ADAL" clId="{91CB56AA-EA07-4E7B-8CF8-687302C44E3C}" dt="2026-04-10T00:03:59.638" v="1" actId="1076"/>
          <ac:picMkLst>
            <pc:docMk/>
            <pc:sldMk cId="671102180" sldId="256"/>
            <ac:picMk id="9" creationId="{4098EBFF-3866-B49B-4B0B-B141F8FD7C54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00:15:48.782" v="157" actId="207"/>
        <pc:sldMkLst>
          <pc:docMk/>
          <pc:sldMk cId="3236124731" sldId="257"/>
        </pc:sldMkLst>
        <pc:spChg chg="del">
          <ac:chgData name="Dawn Holmes" userId="b7a8a953-5552-462e-ab5c-f3e22cb2b5df" providerId="ADAL" clId="{91CB56AA-EA07-4E7B-8CF8-687302C44E3C}" dt="2026-04-10T00:07:20.778" v="68" actId="478"/>
          <ac:spMkLst>
            <pc:docMk/>
            <pc:sldMk cId="3236124731" sldId="257"/>
            <ac:spMk id="2" creationId="{2444FC06-AB93-2A91-F8BC-7F88C14540E7}"/>
          </ac:spMkLst>
        </pc:spChg>
        <pc:spChg chg="del">
          <ac:chgData name="Dawn Holmes" userId="b7a8a953-5552-462e-ab5c-f3e22cb2b5df" providerId="ADAL" clId="{91CB56AA-EA07-4E7B-8CF8-687302C44E3C}" dt="2026-04-10T00:07:20.778" v="68" actId="478"/>
          <ac:spMkLst>
            <pc:docMk/>
            <pc:sldMk cId="3236124731" sldId="257"/>
            <ac:spMk id="3" creationId="{D7C28EEA-1984-B570-42C0-387CCCC2CC4B}"/>
          </ac:spMkLst>
        </pc:spChg>
        <pc:spChg chg="add mod">
          <ac:chgData name="Dawn Holmes" userId="b7a8a953-5552-462e-ab5c-f3e22cb2b5df" providerId="ADAL" clId="{91CB56AA-EA07-4E7B-8CF8-687302C44E3C}" dt="2026-04-10T00:11:34.641" v="132" actId="1037"/>
          <ac:spMkLst>
            <pc:docMk/>
            <pc:sldMk cId="3236124731" sldId="257"/>
            <ac:spMk id="10" creationId="{EB9592D7-5ABA-6F22-8F03-46F412E4230A}"/>
          </ac:spMkLst>
        </pc:spChg>
        <pc:spChg chg="add mod">
          <ac:chgData name="Dawn Holmes" userId="b7a8a953-5552-462e-ab5c-f3e22cb2b5df" providerId="ADAL" clId="{91CB56AA-EA07-4E7B-8CF8-687302C44E3C}" dt="2026-04-10T00:11:55.334" v="137" actId="1076"/>
          <ac:spMkLst>
            <pc:docMk/>
            <pc:sldMk cId="3236124731" sldId="257"/>
            <ac:spMk id="11" creationId="{31C2CAF5-F981-56AC-CE9A-48E4ED267122}"/>
          </ac:spMkLst>
        </pc:spChg>
        <pc:spChg chg="add mod">
          <ac:chgData name="Dawn Holmes" userId="b7a8a953-5552-462e-ab5c-f3e22cb2b5df" providerId="ADAL" clId="{91CB56AA-EA07-4E7B-8CF8-687302C44E3C}" dt="2026-04-10T00:11:51.534" v="136" actId="1076"/>
          <ac:spMkLst>
            <pc:docMk/>
            <pc:sldMk cId="3236124731" sldId="257"/>
            <ac:spMk id="12" creationId="{92266FC2-DB7F-D82B-A19A-A37A086A7289}"/>
          </ac:spMkLst>
        </pc:spChg>
        <pc:spChg chg="add mod">
          <ac:chgData name="Dawn Holmes" userId="b7a8a953-5552-462e-ab5c-f3e22cb2b5df" providerId="ADAL" clId="{91CB56AA-EA07-4E7B-8CF8-687302C44E3C}" dt="2026-04-10T00:14:59.734" v="153" actId="20577"/>
          <ac:spMkLst>
            <pc:docMk/>
            <pc:sldMk cId="3236124731" sldId="257"/>
            <ac:spMk id="14" creationId="{EE7B185B-54E3-E067-B15A-9CBDBD1C99E1}"/>
          </ac:spMkLst>
        </pc:spChg>
        <pc:graphicFrameChg chg="add mod modGraphic">
          <ac:chgData name="Dawn Holmes" userId="b7a8a953-5552-462e-ab5c-f3e22cb2b5df" providerId="ADAL" clId="{91CB56AA-EA07-4E7B-8CF8-687302C44E3C}" dt="2026-04-10T00:15:48.782" v="157" actId="207"/>
          <ac:graphicFrameMkLst>
            <pc:docMk/>
            <pc:sldMk cId="3236124731" sldId="257"/>
            <ac:graphicFrameMk id="13" creationId="{C7CD0827-EA43-C1F0-561A-70AADE938095}"/>
          </ac:graphicFrameMkLst>
        </pc:graphicFrameChg>
        <pc:picChg chg="add mod">
          <ac:chgData name="Dawn Holmes" userId="b7a8a953-5552-462e-ab5c-f3e22cb2b5df" providerId="ADAL" clId="{91CB56AA-EA07-4E7B-8CF8-687302C44E3C}" dt="2026-04-10T00:10:39.838" v="97" actId="1076"/>
          <ac:picMkLst>
            <pc:docMk/>
            <pc:sldMk cId="3236124731" sldId="257"/>
            <ac:picMk id="5" creationId="{3F0EFC31-D832-A83B-4399-4367B2A4AFA3}"/>
          </ac:picMkLst>
        </pc:picChg>
        <pc:picChg chg="add mod">
          <ac:chgData name="Dawn Holmes" userId="b7a8a953-5552-462e-ab5c-f3e22cb2b5df" providerId="ADAL" clId="{91CB56AA-EA07-4E7B-8CF8-687302C44E3C}" dt="2026-04-10T00:10:41.952" v="100" actId="1037"/>
          <ac:picMkLst>
            <pc:docMk/>
            <pc:sldMk cId="3236124731" sldId="257"/>
            <ac:picMk id="7" creationId="{00852990-655D-68B0-83DA-67D78DADD1A1}"/>
          </ac:picMkLst>
        </pc:picChg>
        <pc:picChg chg="add mod">
          <ac:chgData name="Dawn Holmes" userId="b7a8a953-5552-462e-ab5c-f3e22cb2b5df" providerId="ADAL" clId="{91CB56AA-EA07-4E7B-8CF8-687302C44E3C}" dt="2026-04-10T00:10:32.752" v="94" actId="1035"/>
          <ac:picMkLst>
            <pc:docMk/>
            <pc:sldMk cId="3236124731" sldId="257"/>
            <ac:picMk id="9" creationId="{7191CD65-C5DB-0057-1E6C-BEBE27B4380D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00:39:38.787" v="276" actId="207"/>
        <pc:sldMkLst>
          <pc:docMk/>
          <pc:sldMk cId="1518503828" sldId="258"/>
        </pc:sldMkLst>
        <pc:spChg chg="del">
          <ac:chgData name="Dawn Holmes" userId="b7a8a953-5552-462e-ab5c-f3e22cb2b5df" providerId="ADAL" clId="{91CB56AA-EA07-4E7B-8CF8-687302C44E3C}" dt="2026-04-10T00:15:58.345" v="159" actId="478"/>
          <ac:spMkLst>
            <pc:docMk/>
            <pc:sldMk cId="1518503828" sldId="258"/>
            <ac:spMk id="2" creationId="{A0F30681-2434-CF53-0499-4D0B4319CAD5}"/>
          </ac:spMkLst>
        </pc:spChg>
        <pc:spChg chg="del">
          <ac:chgData name="Dawn Holmes" userId="b7a8a953-5552-462e-ab5c-f3e22cb2b5df" providerId="ADAL" clId="{91CB56AA-EA07-4E7B-8CF8-687302C44E3C}" dt="2026-04-10T00:15:58.345" v="159" actId="478"/>
          <ac:spMkLst>
            <pc:docMk/>
            <pc:sldMk cId="1518503828" sldId="258"/>
            <ac:spMk id="3" creationId="{0B712C55-8277-DF6E-116D-F4A37D35A59E}"/>
          </ac:spMkLst>
        </pc:spChg>
        <pc:spChg chg="add mod">
          <ac:chgData name="Dawn Holmes" userId="b7a8a953-5552-462e-ab5c-f3e22cb2b5df" providerId="ADAL" clId="{91CB56AA-EA07-4E7B-8CF8-687302C44E3C}" dt="2026-04-10T00:20:33.123" v="191" actId="20577"/>
          <ac:spMkLst>
            <pc:docMk/>
            <pc:sldMk cId="1518503828" sldId="258"/>
            <ac:spMk id="10" creationId="{A4C644EC-7F1B-CB3C-B8B0-0556C8E54295}"/>
          </ac:spMkLst>
        </pc:spChg>
        <pc:spChg chg="add mod">
          <ac:chgData name="Dawn Holmes" userId="b7a8a953-5552-462e-ab5c-f3e22cb2b5df" providerId="ADAL" clId="{91CB56AA-EA07-4E7B-8CF8-687302C44E3C}" dt="2026-04-10T00:21:01.004" v="205" actId="1038"/>
          <ac:spMkLst>
            <pc:docMk/>
            <pc:sldMk cId="1518503828" sldId="258"/>
            <ac:spMk id="11" creationId="{1115D707-9BEE-A510-F553-A588828264F2}"/>
          </ac:spMkLst>
        </pc:spChg>
        <pc:spChg chg="add mod">
          <ac:chgData name="Dawn Holmes" userId="b7a8a953-5552-462e-ab5c-f3e22cb2b5df" providerId="ADAL" clId="{91CB56AA-EA07-4E7B-8CF8-687302C44E3C}" dt="2026-04-10T00:20:53.526" v="197" actId="1076"/>
          <ac:spMkLst>
            <pc:docMk/>
            <pc:sldMk cId="1518503828" sldId="258"/>
            <ac:spMk id="12" creationId="{89287D60-34A8-574D-9545-74A971A9F468}"/>
          </ac:spMkLst>
        </pc:spChg>
        <pc:spChg chg="add mod">
          <ac:chgData name="Dawn Holmes" userId="b7a8a953-5552-462e-ab5c-f3e22cb2b5df" providerId="ADAL" clId="{91CB56AA-EA07-4E7B-8CF8-687302C44E3C}" dt="2026-04-10T00:23:11.736" v="213" actId="1076"/>
          <ac:spMkLst>
            <pc:docMk/>
            <pc:sldMk cId="1518503828" sldId="258"/>
            <ac:spMk id="14" creationId="{3B2FDBA7-536C-E684-E1BC-8BB8189F1A4A}"/>
          </ac:spMkLst>
        </pc:spChg>
        <pc:graphicFrameChg chg="add mod modGraphic">
          <ac:chgData name="Dawn Holmes" userId="b7a8a953-5552-462e-ab5c-f3e22cb2b5df" providerId="ADAL" clId="{91CB56AA-EA07-4E7B-8CF8-687302C44E3C}" dt="2026-04-10T00:39:38.787" v="276" actId="207"/>
          <ac:graphicFrameMkLst>
            <pc:docMk/>
            <pc:sldMk cId="1518503828" sldId="258"/>
            <ac:graphicFrameMk id="13" creationId="{4BCDC31A-300A-A2D8-1B88-CB2ED5638C2E}"/>
          </ac:graphicFrameMkLst>
        </pc:graphicFrameChg>
        <pc:picChg chg="add mod">
          <ac:chgData name="Dawn Holmes" userId="b7a8a953-5552-462e-ab5c-f3e22cb2b5df" providerId="ADAL" clId="{91CB56AA-EA07-4E7B-8CF8-687302C44E3C}" dt="2026-04-10T00:19:58.943" v="183" actId="1076"/>
          <ac:picMkLst>
            <pc:docMk/>
            <pc:sldMk cId="1518503828" sldId="258"/>
            <ac:picMk id="5" creationId="{804AB29E-A8FB-B5FA-9436-DBDDD5B8D3C8}"/>
          </ac:picMkLst>
        </pc:picChg>
        <pc:picChg chg="add mod">
          <ac:chgData name="Dawn Holmes" userId="b7a8a953-5552-462e-ab5c-f3e22cb2b5df" providerId="ADAL" clId="{91CB56AA-EA07-4E7B-8CF8-687302C44E3C}" dt="2026-04-10T00:19:49.358" v="178" actId="14100"/>
          <ac:picMkLst>
            <pc:docMk/>
            <pc:sldMk cId="1518503828" sldId="258"/>
            <ac:picMk id="7" creationId="{31C275ED-65FA-CF93-B123-48FB7E2ADC05}"/>
          </ac:picMkLst>
        </pc:picChg>
        <pc:picChg chg="add mod">
          <ac:chgData name="Dawn Holmes" userId="b7a8a953-5552-462e-ab5c-f3e22cb2b5df" providerId="ADAL" clId="{91CB56AA-EA07-4E7B-8CF8-687302C44E3C}" dt="2026-04-10T00:20:57.225" v="199" actId="1038"/>
          <ac:picMkLst>
            <pc:docMk/>
            <pc:sldMk cId="1518503828" sldId="258"/>
            <ac:picMk id="9" creationId="{D96699E4-6F32-DD04-190D-462CD490A237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00:40:07.286" v="279" actId="207"/>
        <pc:sldMkLst>
          <pc:docMk/>
          <pc:sldMk cId="1915205324" sldId="259"/>
        </pc:sldMkLst>
        <pc:spChg chg="del">
          <ac:chgData name="Dawn Holmes" userId="b7a8a953-5552-462e-ab5c-f3e22cb2b5df" providerId="ADAL" clId="{91CB56AA-EA07-4E7B-8CF8-687302C44E3C}" dt="2026-04-10T00:23:26.427" v="215" actId="478"/>
          <ac:spMkLst>
            <pc:docMk/>
            <pc:sldMk cId="1915205324" sldId="259"/>
            <ac:spMk id="2" creationId="{6044D3F1-81A0-D1D7-F856-D64B4E020EC6}"/>
          </ac:spMkLst>
        </pc:spChg>
        <pc:spChg chg="del">
          <ac:chgData name="Dawn Holmes" userId="b7a8a953-5552-462e-ab5c-f3e22cb2b5df" providerId="ADAL" clId="{91CB56AA-EA07-4E7B-8CF8-687302C44E3C}" dt="2026-04-10T00:23:26.427" v="215" actId="478"/>
          <ac:spMkLst>
            <pc:docMk/>
            <pc:sldMk cId="1915205324" sldId="259"/>
            <ac:spMk id="3" creationId="{59380033-5DE7-E83D-5270-EF034405EDF2}"/>
          </ac:spMkLst>
        </pc:spChg>
        <pc:spChg chg="add mod">
          <ac:chgData name="Dawn Holmes" userId="b7a8a953-5552-462e-ab5c-f3e22cb2b5df" providerId="ADAL" clId="{91CB56AA-EA07-4E7B-8CF8-687302C44E3C}" dt="2026-04-10T00:38:06.325" v="265" actId="20577"/>
          <ac:spMkLst>
            <pc:docMk/>
            <pc:sldMk cId="1915205324" sldId="259"/>
            <ac:spMk id="13" creationId="{03DB1E80-AFDC-D491-8B45-6BD00672EB5B}"/>
          </ac:spMkLst>
        </pc:spChg>
        <pc:spChg chg="add mod">
          <ac:chgData name="Dawn Holmes" userId="b7a8a953-5552-462e-ab5c-f3e22cb2b5df" providerId="ADAL" clId="{91CB56AA-EA07-4E7B-8CF8-687302C44E3C}" dt="2026-04-10T00:38:11.506" v="267" actId="20577"/>
          <ac:spMkLst>
            <pc:docMk/>
            <pc:sldMk cId="1915205324" sldId="259"/>
            <ac:spMk id="14" creationId="{B1742107-F1BA-CFCC-ED25-526E2D1498A4}"/>
          </ac:spMkLst>
        </pc:spChg>
        <pc:spChg chg="add mod">
          <ac:chgData name="Dawn Holmes" userId="b7a8a953-5552-462e-ab5c-f3e22cb2b5df" providerId="ADAL" clId="{91CB56AA-EA07-4E7B-8CF8-687302C44E3C}" dt="2026-04-10T00:38:15.913" v="269" actId="20577"/>
          <ac:spMkLst>
            <pc:docMk/>
            <pc:sldMk cId="1915205324" sldId="259"/>
            <ac:spMk id="15" creationId="{43DFC0EA-FF75-AE6F-E5E0-D05A73750442}"/>
          </ac:spMkLst>
        </pc:spChg>
        <pc:spChg chg="add mod">
          <ac:chgData name="Dawn Holmes" userId="b7a8a953-5552-462e-ab5c-f3e22cb2b5df" providerId="ADAL" clId="{91CB56AA-EA07-4E7B-8CF8-687302C44E3C}" dt="2026-04-10T00:39:46.072" v="277" actId="1076"/>
          <ac:spMkLst>
            <pc:docMk/>
            <pc:sldMk cId="1915205324" sldId="259"/>
            <ac:spMk id="16" creationId="{789895BA-E838-DC1B-04CA-412883F277A3}"/>
          </ac:spMkLst>
        </pc:spChg>
        <pc:graphicFrameChg chg="add mod modGraphic">
          <ac:chgData name="Dawn Holmes" userId="b7a8a953-5552-462e-ab5c-f3e22cb2b5df" providerId="ADAL" clId="{91CB56AA-EA07-4E7B-8CF8-687302C44E3C}" dt="2026-04-10T00:40:07.286" v="279" actId="207"/>
          <ac:graphicFrameMkLst>
            <pc:docMk/>
            <pc:sldMk cId="1915205324" sldId="259"/>
            <ac:graphicFrameMk id="12" creationId="{60422062-C86F-0328-BBEB-5600535DA271}"/>
          </ac:graphicFrameMkLst>
        </pc:graphicFrameChg>
        <pc:picChg chg="add mod">
          <ac:chgData name="Dawn Holmes" userId="b7a8a953-5552-462e-ab5c-f3e22cb2b5df" providerId="ADAL" clId="{91CB56AA-EA07-4E7B-8CF8-687302C44E3C}" dt="2026-04-10T00:37:32.984" v="257" actId="1076"/>
          <ac:picMkLst>
            <pc:docMk/>
            <pc:sldMk cId="1915205324" sldId="259"/>
            <ac:picMk id="5" creationId="{48E2DEE8-8F33-3F2A-9300-179593DF7472}"/>
          </ac:picMkLst>
        </pc:picChg>
        <pc:picChg chg="add del mod">
          <ac:chgData name="Dawn Holmes" userId="b7a8a953-5552-462e-ab5c-f3e22cb2b5df" providerId="ADAL" clId="{91CB56AA-EA07-4E7B-8CF8-687302C44E3C}" dt="2026-04-10T00:34:40.502" v="224" actId="478"/>
          <ac:picMkLst>
            <pc:docMk/>
            <pc:sldMk cId="1915205324" sldId="259"/>
            <ac:picMk id="7" creationId="{079BB88F-09E1-7B08-D56D-9758C537CFD9}"/>
          </ac:picMkLst>
        </pc:picChg>
        <pc:picChg chg="add mod">
          <ac:chgData name="Dawn Holmes" userId="b7a8a953-5552-462e-ab5c-f3e22cb2b5df" providerId="ADAL" clId="{91CB56AA-EA07-4E7B-8CF8-687302C44E3C}" dt="2026-04-10T00:37:34.527" v="258" actId="1076"/>
          <ac:picMkLst>
            <pc:docMk/>
            <pc:sldMk cId="1915205324" sldId="259"/>
            <ac:picMk id="9" creationId="{D601282C-5C5E-91B6-E1D2-61070D9475D9}"/>
          </ac:picMkLst>
        </pc:picChg>
        <pc:picChg chg="add mod">
          <ac:chgData name="Dawn Holmes" userId="b7a8a953-5552-462e-ab5c-f3e22cb2b5df" providerId="ADAL" clId="{91CB56AA-EA07-4E7B-8CF8-687302C44E3C}" dt="2026-04-10T00:35:44.759" v="236" actId="1076"/>
          <ac:picMkLst>
            <pc:docMk/>
            <pc:sldMk cId="1915205324" sldId="259"/>
            <ac:picMk id="11" creationId="{DA245C2B-4404-753B-359A-D052C9070925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19:19:42.567" v="598" actId="207"/>
        <pc:sldMkLst>
          <pc:docMk/>
          <pc:sldMk cId="1464122247" sldId="260"/>
        </pc:sldMkLst>
        <pc:spChg chg="del">
          <ac:chgData name="Dawn Holmes" userId="b7a8a953-5552-462e-ab5c-f3e22cb2b5df" providerId="ADAL" clId="{91CB56AA-EA07-4E7B-8CF8-687302C44E3C}" dt="2026-04-10T18:47:22.129" v="281" actId="478"/>
          <ac:spMkLst>
            <pc:docMk/>
            <pc:sldMk cId="1464122247" sldId="260"/>
            <ac:spMk id="2" creationId="{C65DDF6B-A25D-A110-C8FB-1F12BF168CF0}"/>
          </ac:spMkLst>
        </pc:spChg>
        <pc:spChg chg="add mod">
          <ac:chgData name="Dawn Holmes" userId="b7a8a953-5552-462e-ab5c-f3e22cb2b5df" providerId="ADAL" clId="{91CB56AA-EA07-4E7B-8CF8-687302C44E3C}" dt="2026-04-10T18:56:42.313" v="379" actId="1038"/>
          <ac:spMkLst>
            <pc:docMk/>
            <pc:sldMk cId="1464122247" sldId="260"/>
            <ac:spMk id="3" creationId="{32E8201D-1D57-E8B9-D824-BB366E1C745A}"/>
          </ac:spMkLst>
        </pc:spChg>
        <pc:spChg chg="del">
          <ac:chgData name="Dawn Holmes" userId="b7a8a953-5552-462e-ab5c-f3e22cb2b5df" providerId="ADAL" clId="{91CB56AA-EA07-4E7B-8CF8-687302C44E3C}" dt="2026-04-10T18:47:22.129" v="281" actId="478"/>
          <ac:spMkLst>
            <pc:docMk/>
            <pc:sldMk cId="1464122247" sldId="260"/>
            <ac:spMk id="3" creationId="{3B3D575E-D66B-3305-DB2C-C383FCA8E98F}"/>
          </ac:spMkLst>
        </pc:spChg>
        <pc:spChg chg="add mod">
          <ac:chgData name="Dawn Holmes" userId="b7a8a953-5552-462e-ab5c-f3e22cb2b5df" providerId="ADAL" clId="{91CB56AA-EA07-4E7B-8CF8-687302C44E3C}" dt="2026-04-10T18:56:54.275" v="398" actId="1035"/>
          <ac:spMkLst>
            <pc:docMk/>
            <pc:sldMk cId="1464122247" sldId="260"/>
            <ac:spMk id="4" creationId="{72171C11-B4D6-E26A-7E2B-64B296158C4F}"/>
          </ac:spMkLst>
        </pc:spChg>
        <pc:spChg chg="add mod">
          <ac:chgData name="Dawn Holmes" userId="b7a8a953-5552-462e-ab5c-f3e22cb2b5df" providerId="ADAL" clId="{91CB56AA-EA07-4E7B-8CF8-687302C44E3C}" dt="2026-04-10T18:57:05.656" v="427" actId="1035"/>
          <ac:spMkLst>
            <pc:docMk/>
            <pc:sldMk cId="1464122247" sldId="260"/>
            <ac:spMk id="6" creationId="{89705C28-56E4-28CD-0F90-A58B922DE6C3}"/>
          </ac:spMkLst>
        </pc:spChg>
        <pc:spChg chg="add mod">
          <ac:chgData name="Dawn Holmes" userId="b7a8a953-5552-462e-ab5c-f3e22cb2b5df" providerId="ADAL" clId="{91CB56AA-EA07-4E7B-8CF8-687302C44E3C}" dt="2026-04-10T19:19:12.494" v="595" actId="20577"/>
          <ac:spMkLst>
            <pc:docMk/>
            <pc:sldMk cId="1464122247" sldId="260"/>
            <ac:spMk id="8" creationId="{E55419FD-22AF-22D4-CB24-AD2861AA9D31}"/>
          </ac:spMkLst>
        </pc:spChg>
        <pc:graphicFrameChg chg="add mod modGraphic">
          <ac:chgData name="Dawn Holmes" userId="b7a8a953-5552-462e-ab5c-f3e22cb2b5df" providerId="ADAL" clId="{91CB56AA-EA07-4E7B-8CF8-687302C44E3C}" dt="2026-04-10T19:19:42.567" v="598" actId="207"/>
          <ac:graphicFrameMkLst>
            <pc:docMk/>
            <pc:sldMk cId="1464122247" sldId="260"/>
            <ac:graphicFrameMk id="2" creationId="{A94A1047-D520-C957-F604-368DC38A65EB}"/>
          </ac:graphicFrameMkLst>
        </pc:graphicFrameChg>
        <pc:picChg chg="add mod">
          <ac:chgData name="Dawn Holmes" userId="b7a8a953-5552-462e-ab5c-f3e22cb2b5df" providerId="ADAL" clId="{91CB56AA-EA07-4E7B-8CF8-687302C44E3C}" dt="2026-04-10T18:51:17.147" v="301" actId="1076"/>
          <ac:picMkLst>
            <pc:docMk/>
            <pc:sldMk cId="1464122247" sldId="260"/>
            <ac:picMk id="5" creationId="{BD4E09FA-A893-DBCA-49FC-DB880E685ABC}"/>
          </ac:picMkLst>
        </pc:picChg>
        <pc:picChg chg="add mod">
          <ac:chgData name="Dawn Holmes" userId="b7a8a953-5552-462e-ab5c-f3e22cb2b5df" providerId="ADAL" clId="{91CB56AA-EA07-4E7B-8CF8-687302C44E3C}" dt="2026-04-10T18:51:30.574" v="311" actId="1037"/>
          <ac:picMkLst>
            <pc:docMk/>
            <pc:sldMk cId="1464122247" sldId="260"/>
            <ac:picMk id="7" creationId="{3F14BD5D-4E4C-AA4D-B00F-E21937B93485}"/>
          </ac:picMkLst>
        </pc:picChg>
        <pc:picChg chg="add mod">
          <ac:chgData name="Dawn Holmes" userId="b7a8a953-5552-462e-ab5c-f3e22cb2b5df" providerId="ADAL" clId="{91CB56AA-EA07-4E7B-8CF8-687302C44E3C}" dt="2026-04-10T18:51:32.007" v="315" actId="1037"/>
          <ac:picMkLst>
            <pc:docMk/>
            <pc:sldMk cId="1464122247" sldId="260"/>
            <ac:picMk id="9" creationId="{8DA8B123-1448-9A7A-E4E5-92DF5AD6A918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19:20:04.895" v="602" actId="20577"/>
        <pc:sldMkLst>
          <pc:docMk/>
          <pc:sldMk cId="966401463" sldId="261"/>
        </pc:sldMkLst>
        <pc:spChg chg="del">
          <ac:chgData name="Dawn Holmes" userId="b7a8a953-5552-462e-ab5c-f3e22cb2b5df" providerId="ADAL" clId="{91CB56AA-EA07-4E7B-8CF8-687302C44E3C}" dt="2026-04-10T18:57:31.884" v="430" actId="478"/>
          <ac:spMkLst>
            <pc:docMk/>
            <pc:sldMk cId="966401463" sldId="261"/>
            <ac:spMk id="2" creationId="{A42408BF-C500-DED8-A231-CDA61DF99C10}"/>
          </ac:spMkLst>
        </pc:spChg>
        <pc:spChg chg="del">
          <ac:chgData name="Dawn Holmes" userId="b7a8a953-5552-462e-ab5c-f3e22cb2b5df" providerId="ADAL" clId="{91CB56AA-EA07-4E7B-8CF8-687302C44E3C}" dt="2026-04-10T18:57:25.906" v="429" actId="478"/>
          <ac:spMkLst>
            <pc:docMk/>
            <pc:sldMk cId="966401463" sldId="261"/>
            <ac:spMk id="3" creationId="{801B53B1-37F0-849F-1521-C0AA95C8B681}"/>
          </ac:spMkLst>
        </pc:spChg>
        <pc:spChg chg="add mod">
          <ac:chgData name="Dawn Holmes" userId="b7a8a953-5552-462e-ab5c-f3e22cb2b5df" providerId="ADAL" clId="{91CB56AA-EA07-4E7B-8CF8-687302C44E3C}" dt="2026-04-10T19:11:26.302" v="513" actId="1036"/>
          <ac:spMkLst>
            <pc:docMk/>
            <pc:sldMk cId="966401463" sldId="261"/>
            <ac:spMk id="14" creationId="{C130EE0B-A2C1-8815-1005-0EE157041AD6}"/>
          </ac:spMkLst>
        </pc:spChg>
        <pc:spChg chg="add mod">
          <ac:chgData name="Dawn Holmes" userId="b7a8a953-5552-462e-ab5c-f3e22cb2b5df" providerId="ADAL" clId="{91CB56AA-EA07-4E7B-8CF8-687302C44E3C}" dt="2026-04-10T19:07:03.397" v="468" actId="20577"/>
          <ac:spMkLst>
            <pc:docMk/>
            <pc:sldMk cId="966401463" sldId="261"/>
            <ac:spMk id="15" creationId="{6C47D694-5746-A2F0-9AB7-762671A5F233}"/>
          </ac:spMkLst>
        </pc:spChg>
        <pc:spChg chg="add mod">
          <ac:chgData name="Dawn Holmes" userId="b7a8a953-5552-462e-ab5c-f3e22cb2b5df" providerId="ADAL" clId="{91CB56AA-EA07-4E7B-8CF8-687302C44E3C}" dt="2026-04-10T19:16:11.714" v="571" actId="1036"/>
          <ac:spMkLst>
            <pc:docMk/>
            <pc:sldMk cId="966401463" sldId="261"/>
            <ac:spMk id="16" creationId="{6231AF75-FF48-9D89-B3FA-AE3F7D4FE4CB}"/>
          </ac:spMkLst>
        </pc:spChg>
        <pc:spChg chg="add mod">
          <ac:chgData name="Dawn Holmes" userId="b7a8a953-5552-462e-ab5c-f3e22cb2b5df" providerId="ADAL" clId="{91CB56AA-EA07-4E7B-8CF8-687302C44E3C}" dt="2026-04-10T19:20:04.895" v="602" actId="20577"/>
          <ac:spMkLst>
            <pc:docMk/>
            <pc:sldMk cId="966401463" sldId="261"/>
            <ac:spMk id="18" creationId="{CCC3CC0F-9B80-E509-5BDD-DF27F0BC8C1E}"/>
          </ac:spMkLst>
        </pc:spChg>
        <pc:graphicFrameChg chg="add mod modGraphic">
          <ac:chgData name="Dawn Holmes" userId="b7a8a953-5552-462e-ab5c-f3e22cb2b5df" providerId="ADAL" clId="{91CB56AA-EA07-4E7B-8CF8-687302C44E3C}" dt="2026-04-10T19:20:00.717" v="601" actId="207"/>
          <ac:graphicFrameMkLst>
            <pc:docMk/>
            <pc:sldMk cId="966401463" sldId="261"/>
            <ac:graphicFrameMk id="17" creationId="{CA9A876A-25A9-EA6B-A55E-DA14AF6B95D6}"/>
          </ac:graphicFrameMkLst>
        </pc:graphicFrameChg>
        <pc:picChg chg="add del mod">
          <ac:chgData name="Dawn Holmes" userId="b7a8a953-5552-462e-ab5c-f3e22cb2b5df" providerId="ADAL" clId="{91CB56AA-EA07-4E7B-8CF8-687302C44E3C}" dt="2026-04-10T19:03:30.342" v="435" actId="478"/>
          <ac:picMkLst>
            <pc:docMk/>
            <pc:sldMk cId="966401463" sldId="261"/>
            <ac:picMk id="5" creationId="{7E3AB6E9-D7E6-2E7B-35D3-258534545AAA}"/>
          </ac:picMkLst>
        </pc:picChg>
        <pc:picChg chg="add del mod">
          <ac:chgData name="Dawn Holmes" userId="b7a8a953-5552-462e-ab5c-f3e22cb2b5df" providerId="ADAL" clId="{91CB56AA-EA07-4E7B-8CF8-687302C44E3C}" dt="2026-04-10T19:03:31.209" v="436" actId="478"/>
          <ac:picMkLst>
            <pc:docMk/>
            <pc:sldMk cId="966401463" sldId="261"/>
            <ac:picMk id="7" creationId="{01F4A72A-C753-DEE8-7478-6B614A15E9B8}"/>
          </ac:picMkLst>
        </pc:picChg>
        <pc:picChg chg="add mod">
          <ac:chgData name="Dawn Holmes" userId="b7a8a953-5552-462e-ab5c-f3e22cb2b5df" providerId="ADAL" clId="{91CB56AA-EA07-4E7B-8CF8-687302C44E3C}" dt="2026-04-10T19:11:26.302" v="513" actId="1036"/>
          <ac:picMkLst>
            <pc:docMk/>
            <pc:sldMk cId="966401463" sldId="261"/>
            <ac:picMk id="9" creationId="{BEDD042E-0313-8E95-9AE6-A9F9DF6BE0ED}"/>
          </ac:picMkLst>
        </pc:picChg>
        <pc:picChg chg="add mod">
          <ac:chgData name="Dawn Holmes" userId="b7a8a953-5552-462e-ab5c-f3e22cb2b5df" providerId="ADAL" clId="{91CB56AA-EA07-4E7B-8CF8-687302C44E3C}" dt="2026-04-10T19:05:40.632" v="453" actId="1076"/>
          <ac:picMkLst>
            <pc:docMk/>
            <pc:sldMk cId="966401463" sldId="261"/>
            <ac:picMk id="11" creationId="{C67C697D-3A05-0EC5-98B7-C9DBD98B4C46}"/>
          </ac:picMkLst>
        </pc:picChg>
        <pc:picChg chg="add mod">
          <ac:chgData name="Dawn Holmes" userId="b7a8a953-5552-462e-ab5c-f3e22cb2b5df" providerId="ADAL" clId="{91CB56AA-EA07-4E7B-8CF8-687302C44E3C}" dt="2026-04-10T19:15:57.345" v="565" actId="14100"/>
          <ac:picMkLst>
            <pc:docMk/>
            <pc:sldMk cId="966401463" sldId="261"/>
            <ac:picMk id="13" creationId="{BC456A52-6973-2301-A421-9915F18F407B}"/>
          </ac:picMkLst>
        </pc:picChg>
      </pc:sldChg>
      <pc:sldChg chg="addSp delSp modSp new mod">
        <pc:chgData name="Dawn Holmes" userId="b7a8a953-5552-462e-ab5c-f3e22cb2b5df" providerId="ADAL" clId="{91CB56AA-EA07-4E7B-8CF8-687302C44E3C}" dt="2026-04-10T19:20:28.430" v="605" actId="207"/>
        <pc:sldMkLst>
          <pc:docMk/>
          <pc:sldMk cId="819384647" sldId="262"/>
        </pc:sldMkLst>
        <pc:spChg chg="del">
          <ac:chgData name="Dawn Holmes" userId="b7a8a953-5552-462e-ab5c-f3e22cb2b5df" providerId="ADAL" clId="{91CB56AA-EA07-4E7B-8CF8-687302C44E3C}" dt="2026-04-10T19:12:16.823" v="537" actId="478"/>
          <ac:spMkLst>
            <pc:docMk/>
            <pc:sldMk cId="819384647" sldId="262"/>
            <ac:spMk id="2" creationId="{1510CB25-0FDE-4C9B-F3CA-361B7CAFA9FB}"/>
          </ac:spMkLst>
        </pc:spChg>
        <pc:spChg chg="del">
          <ac:chgData name="Dawn Holmes" userId="b7a8a953-5552-462e-ab5c-f3e22cb2b5df" providerId="ADAL" clId="{91CB56AA-EA07-4E7B-8CF8-687302C44E3C}" dt="2026-04-10T19:12:16.823" v="537" actId="478"/>
          <ac:spMkLst>
            <pc:docMk/>
            <pc:sldMk cId="819384647" sldId="262"/>
            <ac:spMk id="3" creationId="{A77B31E2-21C7-2F63-C7B6-832557001B12}"/>
          </ac:spMkLst>
        </pc:spChg>
        <pc:spChg chg="add mod">
          <ac:chgData name="Dawn Holmes" userId="b7a8a953-5552-462e-ab5c-f3e22cb2b5df" providerId="ADAL" clId="{91CB56AA-EA07-4E7B-8CF8-687302C44E3C}" dt="2026-04-10T19:16:26.985" v="575" actId="20577"/>
          <ac:spMkLst>
            <pc:docMk/>
            <pc:sldMk cId="819384647" sldId="262"/>
            <ac:spMk id="10" creationId="{9C949160-A7AA-9009-085E-2070775B20BF}"/>
          </ac:spMkLst>
        </pc:spChg>
        <pc:spChg chg="add mod">
          <ac:chgData name="Dawn Holmes" userId="b7a8a953-5552-462e-ab5c-f3e22cb2b5df" providerId="ADAL" clId="{91CB56AA-EA07-4E7B-8CF8-687302C44E3C}" dt="2026-04-10T19:16:38.293" v="578" actId="20577"/>
          <ac:spMkLst>
            <pc:docMk/>
            <pc:sldMk cId="819384647" sldId="262"/>
            <ac:spMk id="11" creationId="{034DF85F-DD48-216F-57BA-61BA7DE46BBC}"/>
          </ac:spMkLst>
        </pc:spChg>
        <pc:spChg chg="add mod">
          <ac:chgData name="Dawn Holmes" userId="b7a8a953-5552-462e-ab5c-f3e22cb2b5df" providerId="ADAL" clId="{91CB56AA-EA07-4E7B-8CF8-687302C44E3C}" dt="2026-04-10T19:16:50.173" v="585" actId="1038"/>
          <ac:spMkLst>
            <pc:docMk/>
            <pc:sldMk cId="819384647" sldId="262"/>
            <ac:spMk id="12" creationId="{64283782-10C0-1A1F-2F7D-3AA9281F6203}"/>
          </ac:spMkLst>
        </pc:spChg>
        <pc:spChg chg="add mod">
          <ac:chgData name="Dawn Holmes" userId="b7a8a953-5552-462e-ab5c-f3e22cb2b5df" providerId="ADAL" clId="{91CB56AA-EA07-4E7B-8CF8-687302C44E3C}" dt="2026-04-10T19:18:55.804" v="594" actId="20577"/>
          <ac:spMkLst>
            <pc:docMk/>
            <pc:sldMk cId="819384647" sldId="262"/>
            <ac:spMk id="14" creationId="{D40F3CC5-1F72-A301-753D-8F63542CD82D}"/>
          </ac:spMkLst>
        </pc:spChg>
        <pc:graphicFrameChg chg="add mod modGraphic">
          <ac:chgData name="Dawn Holmes" userId="b7a8a953-5552-462e-ab5c-f3e22cb2b5df" providerId="ADAL" clId="{91CB56AA-EA07-4E7B-8CF8-687302C44E3C}" dt="2026-04-10T19:20:28.430" v="605" actId="207"/>
          <ac:graphicFrameMkLst>
            <pc:docMk/>
            <pc:sldMk cId="819384647" sldId="262"/>
            <ac:graphicFrameMk id="13" creationId="{7DE9714F-4029-C067-462D-BFEF940C7B48}"/>
          </ac:graphicFrameMkLst>
        </pc:graphicFrameChg>
        <pc:picChg chg="add mod">
          <ac:chgData name="Dawn Holmes" userId="b7a8a953-5552-462e-ab5c-f3e22cb2b5df" providerId="ADAL" clId="{91CB56AA-EA07-4E7B-8CF8-687302C44E3C}" dt="2026-04-10T19:15:01.761" v="561" actId="1076"/>
          <ac:picMkLst>
            <pc:docMk/>
            <pc:sldMk cId="819384647" sldId="262"/>
            <ac:picMk id="5" creationId="{8D0DB96A-FFAE-620D-F38B-5BA8C345E7EC}"/>
          </ac:picMkLst>
        </pc:picChg>
        <pc:picChg chg="add mod">
          <ac:chgData name="Dawn Holmes" userId="b7a8a953-5552-462e-ab5c-f3e22cb2b5df" providerId="ADAL" clId="{91CB56AA-EA07-4E7B-8CF8-687302C44E3C}" dt="2026-04-10T19:15:03.145" v="562" actId="1076"/>
          <ac:picMkLst>
            <pc:docMk/>
            <pc:sldMk cId="819384647" sldId="262"/>
            <ac:picMk id="7" creationId="{1C4B4262-1126-7ADD-1E62-BE98E22CDEB8}"/>
          </ac:picMkLst>
        </pc:picChg>
        <pc:picChg chg="add mod">
          <ac:chgData name="Dawn Holmes" userId="b7a8a953-5552-462e-ab5c-f3e22cb2b5df" providerId="ADAL" clId="{91CB56AA-EA07-4E7B-8CF8-687302C44E3C}" dt="2026-04-10T19:15:00.529" v="560" actId="1076"/>
          <ac:picMkLst>
            <pc:docMk/>
            <pc:sldMk cId="819384647" sldId="262"/>
            <ac:picMk id="9" creationId="{91B82DF7-8B48-86E1-4AED-1FD327949BA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96484"/>
            <a:ext cx="103632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802717"/>
            <a:ext cx="91440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39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942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6834"/>
            <a:ext cx="2628900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6834"/>
            <a:ext cx="7734300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929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689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79653"/>
            <a:ext cx="10515600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119286"/>
            <a:ext cx="10515600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953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34167"/>
            <a:ext cx="518160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925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6836"/>
            <a:ext cx="10515600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41551"/>
            <a:ext cx="5157787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340100"/>
            <a:ext cx="5157787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41551"/>
            <a:ext cx="5183188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340100"/>
            <a:ext cx="5183188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437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111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48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316569"/>
            <a:ext cx="6172200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954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9600"/>
            <a:ext cx="3932237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316569"/>
            <a:ext cx="6172200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43200"/>
            <a:ext cx="3932237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943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6836"/>
            <a:ext cx="1051560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34167"/>
            <a:ext cx="1051560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FD7A87-AAA0-401E-88DC-3B81ED027E48}" type="datetimeFigureOut">
              <a:rPr lang="en-US" smtClean="0"/>
              <a:t>4/11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475136"/>
            <a:ext cx="411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475136"/>
            <a:ext cx="2743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B92342-F925-49A9-8E1A-022C8B7E7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298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4" Type="http://schemas.openxmlformats.org/officeDocument/2006/relationships/image" Target="../media/image3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4" Type="http://schemas.openxmlformats.org/officeDocument/2006/relationships/image" Target="../media/image6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4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4" Type="http://schemas.openxmlformats.org/officeDocument/2006/relationships/image" Target="../media/image12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4" Type="http://schemas.openxmlformats.org/officeDocument/2006/relationships/image" Target="../media/image15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"/><Relationship Id="rId4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4" Type="http://schemas.openxmlformats.org/officeDocument/2006/relationships/image" Target="../media/image21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E1CC93BD-108A-CFA2-CBB7-16CC5CA087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202" y="211748"/>
            <a:ext cx="3454960" cy="2877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BFD5C40A-E2CF-EC8A-4EA0-0DC77CBDAA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46602" y="211748"/>
            <a:ext cx="3366196" cy="28778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098EBFF-3866-B49B-4B0B-B141F8FD7C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7284" y="211748"/>
            <a:ext cx="3366195" cy="287785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6FCCB9F-16C4-D0D3-3F56-6066686397F7}"/>
              </a:ext>
            </a:extLst>
          </p:cNvPr>
          <p:cNvSpPr txBox="1"/>
          <p:nvPr/>
        </p:nvSpPr>
        <p:spPr>
          <a:xfrm>
            <a:off x="2680826" y="211748"/>
            <a:ext cx="1340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mcC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AA663383-1628-7291-2815-9D12F1DC382B}"/>
              </a:ext>
            </a:extLst>
          </p:cNvPr>
          <p:cNvSpPr txBox="1"/>
          <p:nvPr/>
        </p:nvSpPr>
        <p:spPr>
          <a:xfrm>
            <a:off x="6635995" y="211748"/>
            <a:ext cx="116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mcC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79631EA-9229-3F19-A6B1-3D3A89B9F62E}"/>
              </a:ext>
            </a:extLst>
          </p:cNvPr>
          <p:cNvSpPr txBox="1"/>
          <p:nvPr/>
        </p:nvSpPr>
        <p:spPr>
          <a:xfrm>
            <a:off x="9908243" y="211748"/>
            <a:ext cx="1697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OmcC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952E3C18-079C-AB36-668D-C04B8D602F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9822127"/>
              </p:ext>
            </p:extLst>
          </p:nvPr>
        </p:nvGraphicFramePr>
        <p:xfrm>
          <a:off x="213618" y="3394930"/>
          <a:ext cx="11853525" cy="42031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36306">
                  <a:extLst>
                    <a:ext uri="{9D8B030D-6E8A-4147-A177-3AD203B41FA5}">
                      <a16:colId xmlns:a16="http://schemas.microsoft.com/office/drawing/2014/main" xmlns="" val="1242864238"/>
                    </a:ext>
                  </a:extLst>
                </a:gridCol>
                <a:gridCol w="8817219">
                  <a:extLst>
                    <a:ext uri="{9D8B030D-6E8A-4147-A177-3AD203B41FA5}">
                      <a16:colId xmlns:a16="http://schemas.microsoft.com/office/drawing/2014/main" xmlns="" val="3619075633"/>
                    </a:ext>
                  </a:extLst>
                </a:gridCol>
              </a:tblGrid>
              <a:tr h="237978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OmcC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20549476"/>
                  </a:ext>
                </a:extLst>
              </a:tr>
              <a:tr h="3126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3.7%, LT=91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06158142"/>
                  </a:ext>
                </a:extLst>
              </a:tr>
              <a:tr h="223129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.8 Å, TM-score=0.97, MaxSub-score=0.90, GDT-TS-score=0.92, GDT-HA-score=0.8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91374177"/>
                  </a:ext>
                </a:extLst>
              </a:tr>
              <a:tr h="29776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8 Å (across 745 pairs), 0.53 Å (across 658 pruned pairs), 11.7% of protein deviates &gt;2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92014477"/>
                  </a:ext>
                </a:extLst>
              </a:tr>
              <a:tr h="30206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6.64%, LT=36.9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6605956"/>
                  </a:ext>
                </a:extLst>
              </a:tr>
              <a:tr h="30636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8.8%, LT=19.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818105"/>
                  </a:ext>
                </a:extLst>
              </a:tr>
              <a:tr h="2168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1% (50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17944072"/>
                  </a:ext>
                </a:extLst>
              </a:tr>
              <a:tr h="31496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13, df = 1, p-value =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2507855"/>
                  </a:ext>
                </a:extLst>
              </a:tr>
              <a:tr h="20202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73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51401939"/>
                  </a:ext>
                </a:extLst>
              </a:tr>
              <a:tr h="276664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.66 Å, LT=6.7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46283818"/>
                  </a:ext>
                </a:extLst>
              </a:tr>
              <a:tr h="2340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25, df = 40, p-value =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79824569"/>
                  </a:ext>
                </a:extLst>
              </a:tr>
              <a:tr h="16803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75 Å, LT=1.7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27486355"/>
                  </a:ext>
                </a:extLst>
              </a:tr>
              <a:tr h="28956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14, df = 79, p-value = 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061260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0.004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t = 0.07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143, p-value = 0.9, 95% CI: -0.09 to 0.1;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e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 distance is 0.55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maller in LT than PCA (p=0.004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95681716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F866B512-F850-8A8C-073D-65EC2B8C9C48}"/>
              </a:ext>
            </a:extLst>
          </p:cNvPr>
          <p:cNvSpPr txBox="1"/>
          <p:nvPr/>
        </p:nvSpPr>
        <p:spPr>
          <a:xfrm>
            <a:off x="488838" y="7759005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(A) Tertiary structures of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Omc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were predicted with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urple regions indicate the locations of </a:t>
            </a:r>
            <a:r>
              <a:rPr lang="en-US" sz="1200" b="0" i="0" u="none" strike="noStrike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uctures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erimposed using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residue Cα-</a:t>
            </a:r>
            <a:r>
              <a:rPr lang="en-US" sz="1200" b="0" i="0" u="none" strike="noStrike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MSD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lor is ramped from blue to red. Residues are colored on a continuous gradient: Blue indicates the highest similarity (RM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b="0" i="0" u="sng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</a:p>
        </p:txBody>
      </p:sp>
    </p:spTree>
    <p:extLst>
      <p:ext uri="{BB962C8B-B14F-4D97-AF65-F5344CB8AC3E}">
        <p14:creationId xmlns:p14="http://schemas.microsoft.com/office/powerpoint/2010/main" val="671102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3F0EFC31-D832-A83B-4399-4367B2A4AF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7974" y="581133"/>
            <a:ext cx="3989711" cy="27942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00852990-655D-68B0-83DA-67D78DADD1A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529" y="581133"/>
            <a:ext cx="3989711" cy="27942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7191CD65-C5DB-0057-1E6C-BEBE27B438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315" y="196133"/>
            <a:ext cx="3209925" cy="36861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EB9592D7-5ABA-6F22-8F03-46F412E4230A}"/>
              </a:ext>
            </a:extLst>
          </p:cNvPr>
          <p:cNvSpPr txBox="1"/>
          <p:nvPr/>
        </p:nvSpPr>
        <p:spPr>
          <a:xfrm>
            <a:off x="2294692" y="169493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I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31C2CAF5-F981-56AC-CE9A-48E4ED267122}"/>
              </a:ext>
            </a:extLst>
          </p:cNvPr>
          <p:cNvSpPr txBox="1"/>
          <p:nvPr/>
        </p:nvSpPr>
        <p:spPr>
          <a:xfrm>
            <a:off x="6655815" y="545075"/>
            <a:ext cx="961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I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2266FC2-DB7F-D82B-A19A-A37A086A7289}"/>
              </a:ext>
            </a:extLst>
          </p:cNvPr>
          <p:cNvSpPr txBox="1"/>
          <p:nvPr/>
        </p:nvSpPr>
        <p:spPr>
          <a:xfrm>
            <a:off x="10430183" y="560795"/>
            <a:ext cx="1499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I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C7CD0827-EA43-C1F0-561A-70AADE9380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5322366"/>
              </p:ext>
            </p:extLst>
          </p:nvPr>
        </p:nvGraphicFramePr>
        <p:xfrm>
          <a:off x="933554" y="4239578"/>
          <a:ext cx="9413660" cy="3673231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130090">
                  <a:extLst>
                    <a:ext uri="{9D8B030D-6E8A-4147-A177-3AD203B41FA5}">
                      <a16:colId xmlns:a16="http://schemas.microsoft.com/office/drawing/2014/main" xmlns="" val="3519486282"/>
                    </a:ext>
                  </a:extLst>
                </a:gridCol>
                <a:gridCol w="6283570">
                  <a:extLst>
                    <a:ext uri="{9D8B030D-6E8A-4147-A177-3AD203B41FA5}">
                      <a16:colId xmlns:a16="http://schemas.microsoft.com/office/drawing/2014/main" xmlns="" val="2525047161"/>
                    </a:ext>
                  </a:extLst>
                </a:gridCol>
              </a:tblGrid>
              <a:tr h="237978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I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29973886"/>
                  </a:ext>
                </a:extLst>
              </a:tr>
              <a:tr h="24227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00%, LT=99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39330102"/>
                  </a:ext>
                </a:extLst>
              </a:tr>
              <a:tr h="19968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45 Å, TM-score=0.99, MaxSub-score=0.98, GDT-TS-score=0.99, GDT-HA-score=0.9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854136302"/>
                  </a:ext>
                </a:extLst>
              </a:tr>
              <a:tr h="2825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5 Å (across all 380 pairs), 0.36 Å (across 377 pruned pairs), 0.79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26250558"/>
                  </a:ext>
                </a:extLst>
              </a:tr>
              <a:tr h="2317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16%, LT=3.16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22048274"/>
                  </a:ext>
                </a:extLst>
              </a:tr>
              <a:tr h="2594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5.26%, LT=65.5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79840123"/>
                  </a:ext>
                </a:extLst>
              </a:tr>
              <a:tr h="1699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% (3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76281593"/>
                  </a:ext>
                </a:extLst>
              </a:tr>
              <a:tr h="24462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13, df = 1, p-value =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70127392"/>
                  </a:ext>
                </a:extLst>
              </a:tr>
              <a:tr h="22547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73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9716706"/>
                  </a:ext>
                </a:extLst>
              </a:tr>
              <a:tr h="2766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 Å, LT=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61486911"/>
                  </a:ext>
                </a:extLst>
              </a:tr>
              <a:tr h="257517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3, p-value =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2648314"/>
                  </a:ext>
                </a:extLst>
              </a:tr>
              <a:tr h="2618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.29 Å, LT=7.32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306857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1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33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56671670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EE7B185B-54E3-E067-B15A-9CBDBD1C99E1}"/>
              </a:ext>
            </a:extLst>
          </p:cNvPr>
          <p:cNvSpPr txBox="1"/>
          <p:nvPr/>
        </p:nvSpPr>
        <p:spPr>
          <a:xfrm>
            <a:off x="534020" y="8116870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I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6124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04AB29E-A8FB-B5FA-9436-DBDDD5B8D3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646" y="245917"/>
            <a:ext cx="3548927" cy="29348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31C275ED-65FA-CF93-B123-48FB7E2ADC0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2426" y="245918"/>
            <a:ext cx="3497662" cy="29212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D96699E4-6F32-DD04-190D-462CD490A2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3100" y="245917"/>
            <a:ext cx="3548927" cy="29212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A4C644EC-7F1B-CB3C-B8B0-0556C8E54295}"/>
              </a:ext>
            </a:extLst>
          </p:cNvPr>
          <p:cNvSpPr txBox="1"/>
          <p:nvPr/>
        </p:nvSpPr>
        <p:spPr>
          <a:xfrm>
            <a:off x="368927" y="2756300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M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115D707-9BEE-A510-F553-A588828264F2}"/>
              </a:ext>
            </a:extLst>
          </p:cNvPr>
          <p:cNvSpPr txBox="1"/>
          <p:nvPr/>
        </p:nvSpPr>
        <p:spPr>
          <a:xfrm>
            <a:off x="4368725" y="2782253"/>
            <a:ext cx="108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M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9287D60-34A8-574D-9545-74A971A9F468}"/>
              </a:ext>
            </a:extLst>
          </p:cNvPr>
          <p:cNvSpPr txBox="1"/>
          <p:nvPr/>
        </p:nvSpPr>
        <p:spPr>
          <a:xfrm>
            <a:off x="8252426" y="2788017"/>
            <a:ext cx="16275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M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4BCDC31A-300A-A2D8-1B88-CB2ED5638C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6336770"/>
              </p:ext>
            </p:extLst>
          </p:nvPr>
        </p:nvGraphicFramePr>
        <p:xfrm>
          <a:off x="216862" y="3410384"/>
          <a:ext cx="11758275" cy="412613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36306">
                  <a:extLst>
                    <a:ext uri="{9D8B030D-6E8A-4147-A177-3AD203B41FA5}">
                      <a16:colId xmlns:a16="http://schemas.microsoft.com/office/drawing/2014/main" xmlns="" val="629743660"/>
                    </a:ext>
                  </a:extLst>
                </a:gridCol>
                <a:gridCol w="8721969">
                  <a:extLst>
                    <a:ext uri="{9D8B030D-6E8A-4147-A177-3AD203B41FA5}">
                      <a16:colId xmlns:a16="http://schemas.microsoft.com/office/drawing/2014/main" xmlns="" val="934919576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M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03685913"/>
                  </a:ext>
                </a:extLst>
              </a:tr>
              <a:tr h="2657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88.43%, LT=88.13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72066161"/>
                  </a:ext>
                </a:extLst>
              </a:tr>
              <a:tr h="19968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9.7 Å, TM-score=0.93, MaxSub-score=0.90, GDT-TS-score=0.91, GDT-HA-score=0.90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22751601"/>
                  </a:ext>
                </a:extLst>
              </a:tr>
              <a:tr h="32121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3 Å (across 657 pairs), 0.29 Å (across 581 pruned pairs), 8.98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62504051"/>
                  </a:ext>
                </a:extLst>
              </a:tr>
              <a:tr h="27861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6.79%, LT=26.33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6549140"/>
                  </a:ext>
                </a:extLst>
              </a:tr>
              <a:tr h="212578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7.7%, LT=28.0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41184140"/>
                  </a:ext>
                </a:extLst>
              </a:tr>
              <a:tr h="240323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8% (17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14162555"/>
                  </a:ext>
                </a:extLst>
              </a:tr>
              <a:tr h="31496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69, df = 1, p-value =0.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65697167"/>
                  </a:ext>
                </a:extLst>
              </a:tr>
              <a:tr h="27236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, df = 1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34176080"/>
                  </a:ext>
                </a:extLst>
              </a:tr>
              <a:tr h="22977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.07 Å, LT=5.7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017316413"/>
                  </a:ext>
                </a:extLst>
              </a:tr>
              <a:tr h="234071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44, df = 28, p-value =0.6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17226661"/>
                  </a:ext>
                </a:extLst>
              </a:tr>
              <a:tr h="285262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.68 Å, LT=2.6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02817806"/>
                  </a:ext>
                </a:extLst>
              </a:tr>
              <a:tr h="1957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, df = 67, p-value = 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933412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0.005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t = 0.59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143, p-value = 0.5, 95% CI: -0.01 to 0.02;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es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 and 3 distances are 0.06 and 0.04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arger in LT than PCA (p=0.04 and 0.03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76910007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B2FDBA7-536C-E684-E1BC-8BB8189F1A4A}"/>
              </a:ext>
            </a:extLst>
          </p:cNvPr>
          <p:cNvSpPr txBox="1"/>
          <p:nvPr/>
        </p:nvSpPr>
        <p:spPr>
          <a:xfrm>
            <a:off x="534019" y="7804149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M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urple regions indicate the locations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oups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8503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8E2DEE8-8F33-3F2A-9300-179593DF74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19" y="161493"/>
            <a:ext cx="3175891" cy="31457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D601282C-5C5E-91B6-E1D2-61070D9475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406" y="204078"/>
            <a:ext cx="3175891" cy="31457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DA245C2B-4404-753B-359A-D052C907092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1052" y="257244"/>
            <a:ext cx="3175891" cy="3039457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xmlns="" id="{60422062-C86F-0328-BBEB-5600535DA2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5997842"/>
              </p:ext>
            </p:extLst>
          </p:nvPr>
        </p:nvGraphicFramePr>
        <p:xfrm>
          <a:off x="131540" y="3800869"/>
          <a:ext cx="11891625" cy="39865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204825">
                  <a:extLst>
                    <a:ext uri="{9D8B030D-6E8A-4147-A177-3AD203B41FA5}">
                      <a16:colId xmlns:a16="http://schemas.microsoft.com/office/drawing/2014/main" xmlns="" val="2905230211"/>
                    </a:ext>
                  </a:extLst>
                </a:gridCol>
                <a:gridCol w="8686800">
                  <a:extLst>
                    <a:ext uri="{9D8B030D-6E8A-4147-A177-3AD203B41FA5}">
                      <a16:colId xmlns:a16="http://schemas.microsoft.com/office/drawing/2014/main" xmlns="" val="2989284613"/>
                    </a:ext>
                  </a:extLst>
                </a:gridCol>
              </a:tblGrid>
              <a:tr h="243840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K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  <a:endParaRPr lang="en-US" sz="12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62826788"/>
                  </a:ext>
                </a:extLst>
              </a:tr>
              <a:tr h="27305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9.7%, LT=99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70929469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24 Å, TM-score=0.99, MaxSub-score=0.99, GDT-TS-score=0.99, GDT-HA-score=0.9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27162811"/>
                  </a:ext>
                </a:extLst>
              </a:tr>
              <a:tr h="29718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 Å (across all 299 pairs), 0.24 Å (across 299 pruned pairs), 1% of protein deviates &gt;1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16011220"/>
                  </a:ext>
                </a:extLst>
              </a:tr>
              <a:tr h="28575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6.49%, LT=45.4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7747790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0.1%, LT=20.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81013995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% (3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4836792"/>
                  </a:ext>
                </a:extLst>
              </a:tr>
              <a:tr h="28956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3, df = 1, p-value =0.0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55086316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NaN, df = 1, p-value = 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74244708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.32 Å, LT=5.77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98901093"/>
                  </a:ext>
                </a:extLst>
              </a:tr>
              <a:tr h="27051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0.19, df = 17, p-value =0.8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05478033"/>
                  </a:ext>
                </a:extLst>
              </a:tr>
              <a:tr h="26289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.5 Å, LT=2.5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17270371"/>
                  </a:ext>
                </a:extLst>
              </a:tr>
              <a:tr h="21717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NaN, df = 23, p-value = NA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975959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0.012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t = 2.3,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24, p-value = 0.02, 95% CI: 0.0012 to 0.022;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e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5 is 0.034 </a:t>
                      </a:r>
                      <a:r>
                        <a:rPr lang="en-US" sz="12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arger in LT than PCA (p=0.03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68118843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03DB1E80-AFDC-D491-8B45-6BD00672EB5B}"/>
              </a:ext>
            </a:extLst>
          </p:cNvPr>
          <p:cNvSpPr txBox="1"/>
          <p:nvPr/>
        </p:nvSpPr>
        <p:spPr>
          <a:xfrm>
            <a:off x="2337398" y="18801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K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B1742107-F1BA-CFCC-ED25-526E2D1498A4}"/>
              </a:ext>
            </a:extLst>
          </p:cNvPr>
          <p:cNvSpPr txBox="1"/>
          <p:nvPr/>
        </p:nvSpPr>
        <p:spPr>
          <a:xfrm>
            <a:off x="6593237" y="235712"/>
            <a:ext cx="105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K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43DFC0EA-FF75-AE6F-E5E0-D05A73750442}"/>
              </a:ext>
            </a:extLst>
          </p:cNvPr>
          <p:cNvSpPr txBox="1"/>
          <p:nvPr/>
        </p:nvSpPr>
        <p:spPr>
          <a:xfrm>
            <a:off x="9976806" y="270481"/>
            <a:ext cx="15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K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789895BA-E838-DC1B-04CA-412883F277A3}"/>
              </a:ext>
            </a:extLst>
          </p:cNvPr>
          <p:cNvSpPr txBox="1"/>
          <p:nvPr/>
        </p:nvSpPr>
        <p:spPr>
          <a:xfrm>
            <a:off x="534020" y="7885542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K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urple regions indicate the locations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oups. Structures 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5205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D4E09FA-A893-DBCA-49FC-DB880E685A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220" y="233364"/>
            <a:ext cx="3730303" cy="282212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3F14BD5D-4E4C-AA4D-B00F-E21937B934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7867" y="202748"/>
            <a:ext cx="3730303" cy="288335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DA8B123-1448-9A7A-E4E5-92DF5AD6A91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044" y="233364"/>
            <a:ext cx="3730303" cy="282212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A94A1047-D520-C957-F604-368DC38A65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875640"/>
              </p:ext>
            </p:extLst>
          </p:nvPr>
        </p:nvGraphicFramePr>
        <p:xfrm>
          <a:off x="58299" y="3405188"/>
          <a:ext cx="12075401" cy="42155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179051">
                  <a:extLst>
                    <a:ext uri="{9D8B030D-6E8A-4147-A177-3AD203B41FA5}">
                      <a16:colId xmlns:a16="http://schemas.microsoft.com/office/drawing/2014/main" xmlns="" val="3552080669"/>
                    </a:ext>
                  </a:extLst>
                </a:gridCol>
                <a:gridCol w="8896350">
                  <a:extLst>
                    <a:ext uri="{9D8B030D-6E8A-4147-A177-3AD203B41FA5}">
                      <a16:colId xmlns:a16="http://schemas.microsoft.com/office/drawing/2014/main" xmlns="" val="1665544614"/>
                    </a:ext>
                  </a:extLst>
                </a:gridCol>
              </a:tblGrid>
              <a:tr h="200726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G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36163423"/>
                  </a:ext>
                </a:extLst>
              </a:tr>
              <a:tr h="32518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1.5%, LT=68.9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28120079"/>
                  </a:ext>
                </a:extLst>
              </a:tr>
              <a:tr h="18294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10.76 Å, TM-score=0.68, MaxSub-score=0.48, GDT-TS-score=0.50, GDT-HA-score=0.3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84258467"/>
                  </a:ext>
                </a:extLst>
              </a:tr>
              <a:tr h="17405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3 Å (across all 671 pairs), 0.89 Å (across 288 pruned pairs), 56.93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28183934"/>
                  </a:ext>
                </a:extLst>
              </a:tr>
              <a:tr h="31756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25.2%, LT=26.8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92552545"/>
                  </a:ext>
                </a:extLst>
              </a:tr>
              <a:tr h="17532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6.8%, LT=16.4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41295491"/>
                  </a:ext>
                </a:extLst>
              </a:tr>
              <a:tr h="28073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1% (43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90233363"/>
                  </a:ext>
                </a:extLst>
              </a:tr>
              <a:tr h="25279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8, df = 1, p-value =0.1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85445053"/>
                  </a:ext>
                </a:extLst>
              </a:tr>
              <a:tr h="30105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2, df = 1, p-value = 0.1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07299693"/>
                  </a:ext>
                </a:extLst>
              </a:tr>
              <a:tr h="29216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5.83 Å, LT=6.21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78948356"/>
                  </a:ext>
                </a:extLst>
              </a:tr>
              <a:tr h="32137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1.65, df = 28, p-value =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62587675"/>
                  </a:ext>
                </a:extLst>
              </a:tr>
              <a:tr h="274386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36 Å, LT=1.2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10414894"/>
                  </a:ext>
                </a:extLst>
              </a:tr>
              <a:tr h="22739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93, df = 82, p-value = 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332486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0.012 Å; t = 2.3, df = 24, p-value = 0.1, 95% CI: 0.0012 to 0.022; Heme 10 is 2.6 Å smaller (p=0.002); Hemes 8,12, and 13 are 1.8, 3.8, and 1.4 Å larger in LT than PCA (p=0.002, 0.007, 0.015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5586637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2E8201D-1D57-E8B9-D824-BB366E1C745A}"/>
              </a:ext>
            </a:extLst>
          </p:cNvPr>
          <p:cNvSpPr txBox="1"/>
          <p:nvPr/>
        </p:nvSpPr>
        <p:spPr>
          <a:xfrm>
            <a:off x="352278" y="23336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G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72171C11-B4D6-E26A-7E2B-64B296158C4F}"/>
              </a:ext>
            </a:extLst>
          </p:cNvPr>
          <p:cNvSpPr txBox="1"/>
          <p:nvPr/>
        </p:nvSpPr>
        <p:spPr>
          <a:xfrm>
            <a:off x="4311655" y="214000"/>
            <a:ext cx="1050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G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89705C28-56E4-28CD-0F90-A58B922DE6C3}"/>
              </a:ext>
            </a:extLst>
          </p:cNvPr>
          <p:cNvSpPr txBox="1"/>
          <p:nvPr/>
        </p:nvSpPr>
        <p:spPr>
          <a:xfrm>
            <a:off x="8275314" y="194710"/>
            <a:ext cx="15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G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E55419FD-22AF-22D4-CB24-AD2861AA9D31}"/>
              </a:ext>
            </a:extLst>
          </p:cNvPr>
          <p:cNvSpPr txBox="1"/>
          <p:nvPr/>
        </p:nvSpPr>
        <p:spPr>
          <a:xfrm>
            <a:off x="342220" y="7825384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G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urple regions indicate the locations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oups. Structures 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41222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BEDD042E-0313-8E95-9AE6-A9F9DF6BE0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050" y="767079"/>
            <a:ext cx="4112258" cy="2245701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C67C697D-3A05-0EC5-98B7-C9DBD98B4C4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9274" y="394610"/>
            <a:ext cx="3333750" cy="3085987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BC456A52-6973-2301-A421-9915F18F407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31090" y="394609"/>
            <a:ext cx="3333750" cy="3085988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C130EE0B-A2C1-8815-1005-0EE157041AD6}"/>
              </a:ext>
            </a:extLst>
          </p:cNvPr>
          <p:cNvSpPr txBox="1"/>
          <p:nvPr/>
        </p:nvSpPr>
        <p:spPr>
          <a:xfrm>
            <a:off x="3130599" y="2645970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F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C47D694-5746-A2F0-9AB7-762671A5F233}"/>
              </a:ext>
            </a:extLst>
          </p:cNvPr>
          <p:cNvSpPr txBox="1"/>
          <p:nvPr/>
        </p:nvSpPr>
        <p:spPr>
          <a:xfrm>
            <a:off x="7004203" y="3114082"/>
            <a:ext cx="1003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F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6231AF75-FF48-9D89-B3FA-AE3F7D4FE4CB}"/>
              </a:ext>
            </a:extLst>
          </p:cNvPr>
          <p:cNvSpPr txBox="1"/>
          <p:nvPr/>
        </p:nvSpPr>
        <p:spPr>
          <a:xfrm>
            <a:off x="10221177" y="3108676"/>
            <a:ext cx="1542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F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xmlns="" id="{CA9A876A-25A9-EA6B-A55E-DA14AF6B95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4226601"/>
              </p:ext>
            </p:extLst>
          </p:nvPr>
        </p:nvGraphicFramePr>
        <p:xfrm>
          <a:off x="994364" y="3692056"/>
          <a:ext cx="9103601" cy="42188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64751">
                  <a:extLst>
                    <a:ext uri="{9D8B030D-6E8A-4147-A177-3AD203B41FA5}">
                      <a16:colId xmlns:a16="http://schemas.microsoft.com/office/drawing/2014/main" xmlns="" val="3237954451"/>
                    </a:ext>
                  </a:extLst>
                </a:gridCol>
                <a:gridCol w="6038850">
                  <a:extLst>
                    <a:ext uri="{9D8B030D-6E8A-4147-A177-3AD203B41FA5}">
                      <a16:colId xmlns:a16="http://schemas.microsoft.com/office/drawing/2014/main" xmlns="" val="393968275"/>
                    </a:ext>
                  </a:extLst>
                </a:gridCol>
              </a:tblGrid>
              <a:tr h="24584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F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56219189"/>
                  </a:ext>
                </a:extLst>
              </a:tr>
              <a:tr h="2941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85.3%, LT=83.1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621025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9.97 Å, TM-score=0.64, MaxSub-score=0.56, GDT-TS-score=0.60, GDT-HA-score=0.45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948855573"/>
                  </a:ext>
                </a:extLst>
              </a:tr>
              <a:tr h="2471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7 Å (across all 136 pairs), 0.82 Å (across 64 pruned pairs), 52.21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82804166"/>
                  </a:ext>
                </a:extLst>
              </a:tr>
              <a:tr h="25727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9.7%, LT=41.9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66897284"/>
                  </a:ext>
                </a:extLst>
              </a:tr>
              <a:tr h="2293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1.8%, LT=12.5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55311479"/>
                  </a:ext>
                </a:extLst>
              </a:tr>
              <a:tr h="2394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% (17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13161075"/>
                  </a:ext>
                </a:extLst>
              </a:tr>
              <a:tr h="2306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8, df = 1, p-value =0.1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945553732"/>
                  </a:ext>
                </a:extLst>
              </a:tr>
              <a:tr h="27886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07, df = 1, p-value = 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10370838"/>
                  </a:ext>
                </a:extLst>
              </a:tr>
              <a:tr h="3271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6 Å, LT=6.33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354010"/>
                  </a:ext>
                </a:extLst>
              </a:tr>
              <a:tr h="2801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-1.41, df = 8, p-value =0.1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92471984"/>
                  </a:ext>
                </a:extLst>
              </a:tr>
              <a:tr h="2902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1.33 Å, LT=1.06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63795772"/>
                  </a:ext>
                </a:extLst>
              </a:tr>
              <a:tr h="24330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1.15, df = 11, p-value = 0.2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598951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ces in heme distan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difference = 2.1 Å; t = 2.5 df = 24, p-value = 0.01, 95% CI: 0.36 to 3.82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09038149"/>
                  </a:ext>
                </a:extLst>
              </a:tr>
            </a:tbl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CCC3CC0F-9B80-E509-5BDD-DF27F0BC8C1E}"/>
              </a:ext>
            </a:extLst>
          </p:cNvPr>
          <p:cNvSpPr txBox="1"/>
          <p:nvPr/>
        </p:nvSpPr>
        <p:spPr>
          <a:xfrm>
            <a:off x="342220" y="8113245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F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F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urple regions indicate the locations of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roups. Structures 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64014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D0DB96A-FFAE-620D-F38B-5BA8C345E7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2887" y="165886"/>
            <a:ext cx="2583145" cy="2676076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1C4B4262-1126-7ADD-1E62-BE98E22CDE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5968" y="128573"/>
            <a:ext cx="2583145" cy="2713389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91B82DF7-8B48-86E1-4AED-1FD327949BA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4427" y="147229"/>
            <a:ext cx="2583146" cy="2713389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9C949160-A7AA-9009-085E-2070775B20BF}"/>
              </a:ext>
            </a:extLst>
          </p:cNvPr>
          <p:cNvSpPr txBox="1"/>
          <p:nvPr/>
        </p:nvSpPr>
        <p:spPr>
          <a:xfrm>
            <a:off x="3212344" y="172367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E</a:t>
            </a:r>
            <a:r>
              <a:rPr lang="en-US" b="1" dirty="0">
                <a:latin typeface="Times New Roman"/>
                <a:cs typeface="Times New Roman"/>
              </a:rPr>
              <a:t> PC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034DF85F-DD48-216F-57BA-61BA7DE46BBC}"/>
              </a:ext>
            </a:extLst>
          </p:cNvPr>
          <p:cNvSpPr txBox="1"/>
          <p:nvPr/>
        </p:nvSpPr>
        <p:spPr>
          <a:xfrm>
            <a:off x="6352042" y="138835"/>
            <a:ext cx="1025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E</a:t>
            </a:r>
            <a:r>
              <a:rPr lang="en-US" b="1" dirty="0">
                <a:latin typeface="Times New Roman"/>
                <a:cs typeface="Times New Roman"/>
              </a:rPr>
              <a:t> L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4283782-10C0-1A1F-2F7D-3AA9281F6203}"/>
              </a:ext>
            </a:extLst>
          </p:cNvPr>
          <p:cNvSpPr txBox="1"/>
          <p:nvPr/>
        </p:nvSpPr>
        <p:spPr>
          <a:xfrm>
            <a:off x="8745156" y="128573"/>
            <a:ext cx="1563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/>
                <a:cs typeface="Times New Roman"/>
              </a:rPr>
              <a:t>ExtE</a:t>
            </a:r>
            <a:r>
              <a:rPr lang="en-US" b="1" dirty="0">
                <a:latin typeface="Times New Roman"/>
                <a:cs typeface="Times New Roman"/>
              </a:rPr>
              <a:t> PCA/LT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7DE9714F-4029-C067-462D-BFEF940C7B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8899905"/>
              </p:ext>
            </p:extLst>
          </p:nvPr>
        </p:nvGraphicFramePr>
        <p:xfrm>
          <a:off x="1448949" y="3043238"/>
          <a:ext cx="9294101" cy="367250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26651">
                  <a:extLst>
                    <a:ext uri="{9D8B030D-6E8A-4147-A177-3AD203B41FA5}">
                      <a16:colId xmlns:a16="http://schemas.microsoft.com/office/drawing/2014/main" xmlns="" val="2388439481"/>
                    </a:ext>
                  </a:extLst>
                </a:gridCol>
                <a:gridCol w="6267450">
                  <a:extLst>
                    <a:ext uri="{9D8B030D-6E8A-4147-A177-3AD203B41FA5}">
                      <a16:colId xmlns:a16="http://schemas.microsoft.com/office/drawing/2014/main" xmlns="" val="4037256603"/>
                    </a:ext>
                  </a:extLst>
                </a:gridCol>
              </a:tblGrid>
              <a:tr h="245845"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alysis of Ext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ul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98835291"/>
                  </a:ext>
                </a:extLst>
              </a:tr>
              <a:tr h="1988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confidence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92.4%, LT=91.7% confidently predicted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57706074"/>
                  </a:ext>
                </a:extLst>
              </a:tr>
              <a:tr h="20901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M-score result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MSD=0.58 Å, TM-score=0.99, MaxSub-score=0.97, GDT-TS-score=0.98, GDT-HA-score=0.94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32476528"/>
                  </a:ext>
                </a:extLst>
              </a:tr>
              <a:tr h="27632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meraX Matchmaker RMS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8 Å (across all 410 pairs), 0.46 Å (across 403 pruned pairs), 1.71% of protein deviates &gt;2A 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39253560"/>
                  </a:ext>
                </a:extLst>
              </a:tr>
              <a:tr h="17218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helix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4.6%, LT=4.1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83087514"/>
                  </a:ext>
                </a:extLst>
              </a:tr>
              <a:tr h="27759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sheet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72%, LT=71.5%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7986963"/>
                  </a:ext>
                </a:extLst>
              </a:tr>
              <a:tr h="23060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idues structurally changed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3% (19 residues)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769822768"/>
                  </a:ext>
                </a:extLst>
              </a:tr>
              <a:tr h="27886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helice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’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1.8, df = 1, p-value =0.1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75748924"/>
                  </a:ext>
                </a:extLst>
              </a:tr>
              <a:tr h="2699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 test for strands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Nemar's X</a:t>
                      </a:r>
                      <a:r>
                        <a:rPr lang="en-US" sz="1200" baseline="300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07, df = 1, p-value = 0.7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75547143"/>
                  </a:ext>
                </a:extLst>
              </a:tr>
              <a:tr h="20393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3.8 Å, LT=3.4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11443276"/>
                  </a:ext>
                </a:extLst>
              </a:tr>
              <a:tr h="23314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helix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1, df = 4, p-value =0.3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59367100"/>
                  </a:ext>
                </a:extLst>
              </a:tr>
              <a:tr h="224255"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 </a:t>
                      </a:r>
                      <a:r>
                        <a:rPr lang="el-GR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A=8.94 Å, LT=8.88 Å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930925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ired t-test for differences in strand length</a:t>
                      </a:r>
                    </a:p>
                  </a:txBody>
                  <a:tcPr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 = 0.09, df = 32, p-value = 0.9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93139068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40F3CC5-1F72-A301-753D-8F63542CD82D}"/>
              </a:ext>
            </a:extLst>
          </p:cNvPr>
          <p:cNvSpPr txBox="1"/>
          <p:nvPr/>
        </p:nvSpPr>
        <p:spPr>
          <a:xfrm>
            <a:off x="393020" y="7046445"/>
            <a:ext cx="1112396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G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rtiary structures of </a:t>
            </a:r>
            <a:r>
              <a:rPr lang="en-US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E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predicted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visualized in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himeraX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uctures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re superimposed using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chMaker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colored by per-residue Cα-RMSD. Color is ramped from blue to red. Residues are colored on a continuous gradient: Blue indicates the highest similarity (RM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A), white indicates intermediate difference (RMSD ~ 1 A), and red indicates the largest structural difference (RSD </a:t>
            </a:r>
            <a:r>
              <a:rPr lang="en-US" sz="1200" u="sng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&gt;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 A). TM-score was used to determine structure similarities and all statistics were done with the R-stats program.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384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2639</Words>
  <Application>Microsoft Macintosh PowerPoint</Application>
  <PresentationFormat>Custom</PresentationFormat>
  <Paragraphs>220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estern New Englan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n Holmes</dc:creator>
  <cp:lastModifiedBy>Dawn Holmes</cp:lastModifiedBy>
  <cp:revision>7</cp:revision>
  <dcterms:created xsi:type="dcterms:W3CDTF">2026-04-09T23:58:25Z</dcterms:created>
  <dcterms:modified xsi:type="dcterms:W3CDTF">2026-04-11T16:39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cc4f9dd6-a4b8-4763-a61d-db8d0cf51108_Enabled">
    <vt:lpwstr>true</vt:lpwstr>
  </property>
  <property fmtid="{D5CDD505-2E9C-101B-9397-08002B2CF9AE}" pid="3" name="MSIP_Label_cc4f9dd6-a4b8-4763-a61d-db8d0cf51108_SetDate">
    <vt:lpwstr>2026-04-10T00:03:09Z</vt:lpwstr>
  </property>
  <property fmtid="{D5CDD505-2E9C-101B-9397-08002B2CF9AE}" pid="4" name="MSIP_Label_cc4f9dd6-a4b8-4763-a61d-db8d0cf51108_Method">
    <vt:lpwstr>Standard</vt:lpwstr>
  </property>
  <property fmtid="{D5CDD505-2E9C-101B-9397-08002B2CF9AE}" pid="5" name="MSIP_Label_cc4f9dd6-a4b8-4763-a61d-db8d0cf51108_Name">
    <vt:lpwstr>defa4170-0d19-0005-0004-bc88714345d2</vt:lpwstr>
  </property>
  <property fmtid="{D5CDD505-2E9C-101B-9397-08002B2CF9AE}" pid="6" name="MSIP_Label_cc4f9dd6-a4b8-4763-a61d-db8d0cf51108_SiteId">
    <vt:lpwstr>b5a5796f-19a9-493f-9cb2-7a88b4e9b123</vt:lpwstr>
  </property>
  <property fmtid="{D5CDD505-2E9C-101B-9397-08002B2CF9AE}" pid="7" name="MSIP_Label_cc4f9dd6-a4b8-4763-a61d-db8d0cf51108_ActionId">
    <vt:lpwstr>af720c60-3440-4b96-b463-c528853871ff</vt:lpwstr>
  </property>
  <property fmtid="{D5CDD505-2E9C-101B-9397-08002B2CF9AE}" pid="8" name="MSIP_Label_cc4f9dd6-a4b8-4763-a61d-db8d0cf51108_ContentBits">
    <vt:lpwstr>0</vt:lpwstr>
  </property>
  <property fmtid="{D5CDD505-2E9C-101B-9397-08002B2CF9AE}" pid="9" name="MSIP_Label_cc4f9dd6-a4b8-4763-a61d-db8d0cf51108_Tag">
    <vt:lpwstr>10, 3, 0, 1</vt:lpwstr>
  </property>
</Properties>
</file>